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1" d="100"/>
          <a:sy n="91" d="100"/>
        </p:scale>
        <p:origin x="-1218" y="5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92B64C-92A6-4443-B744-C4E22BEFE740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0FB836-0BA7-452A-9E59-68529ED7D3CE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2969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520" y="704528"/>
            <a:ext cx="6586961" cy="446449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71727" y="5601072"/>
            <a:ext cx="491454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.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henylpropanoi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iosynthesis pathway as retrieved from KEGG databas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nzymes phenylalanine ammonia-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lyas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.C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number 4.3.1.24),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innamoy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CoA reductase (E.C. numbe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.2.1.44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innamy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lcohol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ehydrogenas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E.C. numbe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.1.1.195) are highlighted in blue, red and green respectively.</a:t>
            </a:r>
            <a:endParaRPr lang="el-G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04162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2.PPTX</DocumentId>
    <DocumentType xmlns="370fed10-a368-469c-a864-2e77a9536334">Presentation</DocumentType>
    <TitleName xmlns="370fed10-a368-469c-a864-2e77a9536334">Presentation 2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C8B9996C-63EA-423C-BD14-1E77AEF4C6D9}"/>
</file>

<file path=customXml/itemProps2.xml><?xml version="1.0" encoding="utf-8"?>
<ds:datastoreItem xmlns:ds="http://schemas.openxmlformats.org/officeDocument/2006/customXml" ds:itemID="{AEE424D2-B250-4319-AA99-47519671F6EF}"/>
</file>

<file path=customXml/itemProps3.xml><?xml version="1.0" encoding="utf-8"?>
<ds:datastoreItem xmlns:ds="http://schemas.openxmlformats.org/officeDocument/2006/customXml" ds:itemID="{4F8A9A40-77B3-4513-9469-7AB9C59367DC}"/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52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pasia</dc:creator>
  <cp:lastModifiedBy>Koudounas</cp:lastModifiedBy>
  <cp:revision>18</cp:revision>
  <dcterms:created xsi:type="dcterms:W3CDTF">2013-04-30T09:15:21Z</dcterms:created>
  <dcterms:modified xsi:type="dcterms:W3CDTF">2015-07-06T14:55:59Z</dcterms:modified>
</cp:coreProperties>
</file>